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423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Estilo oscuro 2 - Énfasis 5/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Estilo oscuro 2 - Énfasis 3/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Estilo oscuro 2 - Énfasis 1/Énfasis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AF606853-7671-496A-8E4F-DF71F8EC918B}" styleName="Estilo oscuro 1 - Énfasis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Estilo oscuro 1 - Énfasis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Estilo oscuro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66"/>
    <p:restoredTop sz="93575"/>
  </p:normalViewPr>
  <p:slideViewPr>
    <p:cSldViewPr snapToGrid="0">
      <p:cViewPr varScale="1">
        <p:scale>
          <a:sx n="66" d="100"/>
          <a:sy n="66" d="100"/>
        </p:scale>
        <p:origin x="960" y="192"/>
      </p:cViewPr>
      <p:guideLst>
        <p:guide orient="horz" pos="2160"/>
        <p:guide pos="2880"/>
        <p:guide orient="horz" pos="42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D1526C-9095-C846-A70B-0FB3CA36D0E9}" type="datetimeFigureOut">
              <a:rPr lang="es-ES" smtClean="0"/>
              <a:t>3/6/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46150-FE0A-644F-9B06-944E72A71C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4131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108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22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970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103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820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554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33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78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682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624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799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06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CDB820ED-C3C1-FE44-868C-E603B5624E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7474032"/>
              </p:ext>
            </p:extLst>
          </p:nvPr>
        </p:nvGraphicFramePr>
        <p:xfrm>
          <a:off x="668109" y="1525450"/>
          <a:ext cx="7491821" cy="2728565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602524">
                  <a:extLst>
                    <a:ext uri="{9D8B030D-6E8A-4147-A177-3AD203B41FA5}">
                      <a16:colId xmlns:a16="http://schemas.microsoft.com/office/drawing/2014/main" val="1519663688"/>
                    </a:ext>
                  </a:extLst>
                </a:gridCol>
                <a:gridCol w="598305">
                  <a:extLst>
                    <a:ext uri="{9D8B030D-6E8A-4147-A177-3AD203B41FA5}">
                      <a16:colId xmlns:a16="http://schemas.microsoft.com/office/drawing/2014/main" val="1203766495"/>
                    </a:ext>
                  </a:extLst>
                </a:gridCol>
                <a:gridCol w="597602">
                  <a:extLst>
                    <a:ext uri="{9D8B030D-6E8A-4147-A177-3AD203B41FA5}">
                      <a16:colId xmlns:a16="http://schemas.microsoft.com/office/drawing/2014/main" val="3245363714"/>
                    </a:ext>
                  </a:extLst>
                </a:gridCol>
                <a:gridCol w="598305">
                  <a:extLst>
                    <a:ext uri="{9D8B030D-6E8A-4147-A177-3AD203B41FA5}">
                      <a16:colId xmlns:a16="http://schemas.microsoft.com/office/drawing/2014/main" val="3031926599"/>
                    </a:ext>
                  </a:extLst>
                </a:gridCol>
                <a:gridCol w="597602">
                  <a:extLst>
                    <a:ext uri="{9D8B030D-6E8A-4147-A177-3AD203B41FA5}">
                      <a16:colId xmlns:a16="http://schemas.microsoft.com/office/drawing/2014/main" val="1081672931"/>
                    </a:ext>
                  </a:extLst>
                </a:gridCol>
                <a:gridCol w="598305">
                  <a:extLst>
                    <a:ext uri="{9D8B030D-6E8A-4147-A177-3AD203B41FA5}">
                      <a16:colId xmlns:a16="http://schemas.microsoft.com/office/drawing/2014/main" val="1257937339"/>
                    </a:ext>
                  </a:extLst>
                </a:gridCol>
                <a:gridCol w="400745">
                  <a:extLst>
                    <a:ext uri="{9D8B030D-6E8A-4147-A177-3AD203B41FA5}">
                      <a16:colId xmlns:a16="http://schemas.microsoft.com/office/drawing/2014/main" val="367384856"/>
                    </a:ext>
                  </a:extLst>
                </a:gridCol>
                <a:gridCol w="801489">
                  <a:extLst>
                    <a:ext uri="{9D8B030D-6E8A-4147-A177-3AD203B41FA5}">
                      <a16:colId xmlns:a16="http://schemas.microsoft.com/office/drawing/2014/main" val="3338731802"/>
                    </a:ext>
                  </a:extLst>
                </a:gridCol>
                <a:gridCol w="498471">
                  <a:extLst>
                    <a:ext uri="{9D8B030D-6E8A-4147-A177-3AD203B41FA5}">
                      <a16:colId xmlns:a16="http://schemas.microsoft.com/office/drawing/2014/main" val="1837921225"/>
                    </a:ext>
                  </a:extLst>
                </a:gridCol>
                <a:gridCol w="497767">
                  <a:extLst>
                    <a:ext uri="{9D8B030D-6E8A-4147-A177-3AD203B41FA5}">
                      <a16:colId xmlns:a16="http://schemas.microsoft.com/office/drawing/2014/main" val="521637858"/>
                    </a:ext>
                  </a:extLst>
                </a:gridCol>
                <a:gridCol w="498471">
                  <a:extLst>
                    <a:ext uri="{9D8B030D-6E8A-4147-A177-3AD203B41FA5}">
                      <a16:colId xmlns:a16="http://schemas.microsoft.com/office/drawing/2014/main" val="298882451"/>
                    </a:ext>
                  </a:extLst>
                </a:gridCol>
                <a:gridCol w="598305">
                  <a:extLst>
                    <a:ext uri="{9D8B030D-6E8A-4147-A177-3AD203B41FA5}">
                      <a16:colId xmlns:a16="http://schemas.microsoft.com/office/drawing/2014/main" val="2166346015"/>
                    </a:ext>
                  </a:extLst>
                </a:gridCol>
                <a:gridCol w="603930">
                  <a:extLst>
                    <a:ext uri="{9D8B030D-6E8A-4147-A177-3AD203B41FA5}">
                      <a16:colId xmlns:a16="http://schemas.microsoft.com/office/drawing/2014/main" val="3424269821"/>
                    </a:ext>
                  </a:extLst>
                </a:gridCol>
              </a:tblGrid>
              <a:tr h="46199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DB code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RMSD (</a:t>
                      </a:r>
                      <a:r>
                        <a:rPr lang="en-US" sz="1000" b="0" dirty="0" err="1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Å</a:t>
                      </a: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c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Apo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c Apo2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c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LNB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c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H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</a:t>
                      </a:r>
                      <a:r>
                        <a:rPr lang="en-US" sz="1000" b="0" baseline="-2500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Wa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</a:t>
                      </a:r>
                      <a:r>
                        <a:rPr lang="en-US" sz="1000" b="0" baseline="-2500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Rot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4]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19]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6] LNFP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6]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4] LNFP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99354792"/>
                  </a:ext>
                </a:extLst>
              </a:tr>
              <a:tr h="20466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6H9W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c Apo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28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28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34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27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44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7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72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7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46009051"/>
                  </a:ext>
                </a:extLst>
              </a:tr>
              <a:tr h="20466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6H9Z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c Apo2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35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33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35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5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6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8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6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4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6450609"/>
                  </a:ext>
                </a:extLst>
              </a:tr>
              <a:tr h="20466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6H9Y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c LNB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22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4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7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9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84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4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2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82715529"/>
                  </a:ext>
                </a:extLst>
              </a:tr>
              <a:tr h="20466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6HA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c H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37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4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6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8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7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8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88978372"/>
                  </a:ext>
                </a:extLst>
              </a:tr>
              <a:tr h="23195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2DWR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</a:t>
                      </a:r>
                      <a:r>
                        <a:rPr lang="en-US" sz="1000" b="0" baseline="-2500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Wa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46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3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84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7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47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31937990"/>
                  </a:ext>
                </a:extLst>
              </a:tr>
              <a:tr h="23195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5JDB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8]</a:t>
                      </a:r>
                      <a:r>
                        <a:rPr lang="en-US" sz="1000" b="0" baseline="-2500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Rot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5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6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73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5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74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50983365"/>
                  </a:ext>
                </a:extLst>
              </a:tr>
              <a:tr h="20466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2AEN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4] 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9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3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43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60255964"/>
                  </a:ext>
                </a:extLst>
              </a:tr>
              <a:tr h="20466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5VKI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19]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6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6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59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32285881"/>
                  </a:ext>
                </a:extLst>
              </a:tr>
              <a:tr h="20466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5VX9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6] LNFP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7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7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98003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5VX8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6]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,64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49446088"/>
                  </a:ext>
                </a:extLst>
              </a:tr>
              <a:tr h="20466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5VX5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P[4] LNFP1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0" dirty="0">
                          <a:ln w="635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s-ES" sz="1000" b="0" dirty="0">
                        <a:ln w="6350"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459165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3600383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17</TotalTime>
  <Words>195</Words>
  <Application>Microsoft Macintosh PowerPoint</Application>
  <PresentationFormat>Presentación en pantalla (4:3)</PresentationFormat>
  <Paragraphs>15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ús Rodríguez Díaz</dc:creator>
  <cp:lastModifiedBy>Microsoft Office User</cp:lastModifiedBy>
  <cp:revision>55</cp:revision>
  <dcterms:created xsi:type="dcterms:W3CDTF">2018-01-15T13:22:08Z</dcterms:created>
  <dcterms:modified xsi:type="dcterms:W3CDTF">2019-06-03T11:50:52Z</dcterms:modified>
</cp:coreProperties>
</file>